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370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961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694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803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9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188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208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10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766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193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338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505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18C55-CBBA-4262-899B-F21220D84960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50760-3A3C-41FA-8FA5-BC8A26C6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465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F5BC368-A1F0-6BC0-5457-DA737549C4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4710830"/>
              </p:ext>
            </p:extLst>
          </p:nvPr>
        </p:nvGraphicFramePr>
        <p:xfrm>
          <a:off x="1045210" y="1841084"/>
          <a:ext cx="4767580" cy="7377129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157095">
                  <a:extLst>
                    <a:ext uri="{9D8B030D-6E8A-4147-A177-3AD203B41FA5}">
                      <a16:colId xmlns:a16="http://schemas.microsoft.com/office/drawing/2014/main" val="1334271334"/>
                    </a:ext>
                  </a:extLst>
                </a:gridCol>
                <a:gridCol w="2610485">
                  <a:extLst>
                    <a:ext uri="{9D8B030D-6E8A-4147-A177-3AD203B41FA5}">
                      <a16:colId xmlns:a16="http://schemas.microsoft.com/office/drawing/2014/main" val="2246114968"/>
                    </a:ext>
                  </a:extLst>
                </a:gridCol>
              </a:tblGrid>
              <a:tr h="17145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Constitu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Bioactivity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1817770"/>
                  </a:ext>
                </a:extLst>
              </a:tr>
              <a:tr h="52086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2-Undecena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acterial </a:t>
                      </a: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tivity[82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 err="1">
                          <a:solidFill>
                            <a:srgbClr val="191919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maticidal</a:t>
                      </a: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ctivity[83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21296411"/>
                  </a:ext>
                </a:extLst>
              </a:tr>
              <a:tr h="19405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Tetradecan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acterial and antifungal[84]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2458794"/>
                  </a:ext>
                </a:extLst>
              </a:tr>
              <a:tr h="19405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Eicosan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fungal</a:t>
                      </a: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ctivity[85, 86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246440"/>
                  </a:ext>
                </a:extLst>
              </a:tr>
              <a:tr h="19405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Octadecan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microbial activity[87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92175841"/>
                  </a:ext>
                </a:extLst>
              </a:tr>
              <a:tr h="19405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Octadecan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oxidant, Anti-inflammatory[88, 89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80464563"/>
                  </a:ext>
                </a:extLst>
              </a:tr>
              <a:tr h="81121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Hexadecanoic acid, methyl es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fungal potentials[90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cancer,</a:t>
                      </a:r>
                      <a:b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microbial and antioxidant properties[91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69303756"/>
                  </a:ext>
                </a:extLst>
              </a:tr>
              <a:tr h="6948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Cis-9-Hexadecenoic acid (palmitoleic acid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inflammatory mediator [92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acterial, antibiofilm,</a:t>
                      </a:r>
                      <a:b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d antioxidant activities[93]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5038915"/>
                  </a:ext>
                </a:extLst>
              </a:tr>
              <a:tr h="52086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Hexadecanoic acid (palmitic acid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cancer activity[94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microbial activity[95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08004022"/>
                  </a:ext>
                </a:extLst>
              </a:tr>
              <a:tr h="35083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onadecan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ulcer, antioxidant, hepatoprotective[96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528287"/>
                  </a:ext>
                </a:extLst>
              </a:tr>
              <a:tr h="3970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9-Octadecenoic acid, methyl es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oxidant, anticancer[97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10464447"/>
                  </a:ext>
                </a:extLst>
              </a:tr>
              <a:tr h="3970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Octadecanoic acid, methyl es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inflammatory</a:t>
                      </a:r>
                      <a:b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d cytotoxicity activities[98]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84542551"/>
                  </a:ext>
                </a:extLst>
              </a:tr>
              <a:tr h="3970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Octadecanoic acid (Stearic acid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acterial activity[99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82419589"/>
                  </a:ext>
                </a:extLst>
              </a:tr>
              <a:tr h="19405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Oleyl Alcoh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-Roman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tumor Activity</a:t>
                      </a: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[100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24886137"/>
                  </a:ext>
                </a:extLst>
              </a:tr>
              <a:tr h="39703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Cis-11-Eicosenoic acid, methyl es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bacterial activity[101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72668351"/>
                  </a:ext>
                </a:extLst>
              </a:tr>
              <a:tr h="60000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Hexadecanoic acid, 2-hydroxy-1-(hydroxymethyl) ethyl ester (2-Palmitoylglycerol)</a:t>
                      </a:r>
                      <a:r>
                        <a:rPr lang="en-US" sz="1100">
                          <a:effectLst/>
                        </a:rPr>
                        <a:t> 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viral activities[102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i="0" dirty="0">
                          <a:solidFill>
                            <a:srgbClr val="191919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microbial, antioxidant activities[103]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448655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,2-Benzenedicarboxylic acid, mono(2-ethylhexyl) es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cancer potential[104]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microbial agents[105]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19343454"/>
                  </a:ext>
                </a:extLst>
              </a:tr>
              <a:tr h="60000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9-Octadecenoic acid (Z)-, 2,3-dihydroxypropyl ester (Glyceryl monooleate)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lavoring agent in the dairy</a:t>
                      </a:r>
                      <a:b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dustry[106]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1748712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FC3D48D-28C7-65D5-CC94-C6F310CD2EB5}"/>
              </a:ext>
            </a:extLst>
          </p:cNvPr>
          <p:cNvSpPr txBox="1"/>
          <p:nvPr/>
        </p:nvSpPr>
        <p:spPr>
          <a:xfrm>
            <a:off x="993648" y="1564086"/>
            <a:ext cx="532638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Supplementary Table 1: </a:t>
            </a:r>
            <a:r>
              <a:rPr lang="en-US" sz="1200" dirty="0"/>
              <a:t>bioactivity of compounds detected by the GC-MS</a:t>
            </a:r>
            <a:endParaRPr lang="ar-EG" sz="1200" dirty="0"/>
          </a:p>
        </p:txBody>
      </p:sp>
    </p:spTree>
    <p:extLst>
      <p:ext uri="{BB962C8B-B14F-4D97-AF65-F5344CB8AC3E}">
        <p14:creationId xmlns:p14="http://schemas.microsoft.com/office/powerpoint/2010/main" val="1846127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236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imes-Roman</vt:lpstr>
      <vt:lpstr>Office Theme</vt:lpstr>
      <vt:lpstr>PowerPoint Presentation</vt:lpstr>
    </vt:vector>
  </TitlesOfParts>
  <Company>SD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elal</dc:creator>
  <cp:lastModifiedBy>Mohamed Helal</cp:lastModifiedBy>
  <cp:revision>8</cp:revision>
  <dcterms:created xsi:type="dcterms:W3CDTF">2023-01-22T01:31:31Z</dcterms:created>
  <dcterms:modified xsi:type="dcterms:W3CDTF">2023-12-18T15:19:39Z</dcterms:modified>
</cp:coreProperties>
</file>